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6"/>
  </p:notesMasterIdLst>
  <p:sldIdLst>
    <p:sldId id="293" r:id="rId2"/>
    <p:sldId id="301" r:id="rId3"/>
    <p:sldId id="336" r:id="rId4"/>
    <p:sldId id="342" r:id="rId5"/>
  </p:sldIdLst>
  <p:sldSz cx="6858000" cy="9906000" type="A4"/>
  <p:notesSz cx="6794500" cy="9918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5144" autoAdjust="0"/>
    <p:restoredTop sz="96000" autoAdjust="0"/>
  </p:normalViewPr>
  <p:slideViewPr>
    <p:cSldViewPr snapToGrid="0">
      <p:cViewPr varScale="1">
        <p:scale>
          <a:sx n="85" d="100"/>
          <a:sy n="85" d="100"/>
        </p:scale>
        <p:origin x="-3558" y="-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76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76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58D937-D3FA-4E83-A8C7-9E893D35C9AB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39838"/>
            <a:ext cx="2317750" cy="3348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3374"/>
            <a:ext cx="5435600" cy="39054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1044"/>
            <a:ext cx="2944283" cy="49765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21044"/>
            <a:ext cx="2944283" cy="49765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42D2E4-948B-4E4C-8E22-F92BFD3C28E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88011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61941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80156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15104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68026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29132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10910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58133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8052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00774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77753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4136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EDDDCA-9729-4876-A906-060EFE4AAF8C}" type="datetimeFigureOut">
              <a:rPr lang="en-ZA" smtClean="0"/>
              <a:t>2019/02/0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0FF58-5F80-45E3-952F-F66D1749857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83777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01414089\Documents\post doc students\TAMGUE Ousman\1 Paper microRNA\16 Paper prism\8 Prism\S1.em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262" y="341313"/>
            <a:ext cx="6264276" cy="6048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896066" y="9469751"/>
            <a:ext cx="1169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2000" b="1" dirty="0"/>
              <a:t>Figure </a:t>
            </a:r>
            <a:r>
              <a:rPr lang="en-ZA" sz="2000" b="1" dirty="0" smtClean="0"/>
              <a:t>S1</a:t>
            </a:r>
            <a:endParaRPr lang="en-ZA" sz="2000" b="1" dirty="0"/>
          </a:p>
        </p:txBody>
      </p:sp>
    </p:spTree>
    <p:extLst>
      <p:ext uri="{BB962C8B-B14F-4D97-AF65-F5344CB8AC3E}">
        <p14:creationId xmlns:p14="http://schemas.microsoft.com/office/powerpoint/2010/main" val="317519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01414089\Documents\post doc students\TAMGUE Ousman\1 Paper microRNA\16 Paper prism\8 Prism\S2.em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4" y="134937"/>
            <a:ext cx="6666706" cy="71432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896066" y="9469751"/>
            <a:ext cx="1169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2000" b="1" dirty="0"/>
              <a:t>Figure </a:t>
            </a:r>
            <a:r>
              <a:rPr lang="en-ZA" sz="2000" b="1" dirty="0" smtClean="0"/>
              <a:t>S2</a:t>
            </a:r>
            <a:endParaRPr lang="en-ZA" sz="2000" b="1" dirty="0"/>
          </a:p>
        </p:txBody>
      </p:sp>
    </p:spTree>
    <p:extLst>
      <p:ext uri="{BB962C8B-B14F-4D97-AF65-F5344CB8AC3E}">
        <p14:creationId xmlns:p14="http://schemas.microsoft.com/office/powerpoint/2010/main" val="3640545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01414089\Documents\post doc students\TAMGUE Ousman\1 Paper microRNA\16 Paper prism\8 Prism\S3.em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420687"/>
            <a:ext cx="6960225" cy="5865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896066" y="9469751"/>
            <a:ext cx="1169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2000" b="1" dirty="0"/>
              <a:t>Figure </a:t>
            </a:r>
            <a:r>
              <a:rPr lang="en-ZA" sz="2000" b="1" dirty="0" smtClean="0"/>
              <a:t>S3</a:t>
            </a:r>
            <a:endParaRPr lang="en-ZA" sz="2000" b="1" dirty="0"/>
          </a:p>
        </p:txBody>
      </p:sp>
    </p:spTree>
    <p:extLst>
      <p:ext uri="{BB962C8B-B14F-4D97-AF65-F5344CB8AC3E}">
        <p14:creationId xmlns:p14="http://schemas.microsoft.com/office/powerpoint/2010/main" val="4365670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3237920"/>
              </p:ext>
            </p:extLst>
          </p:nvPr>
        </p:nvGraphicFramePr>
        <p:xfrm>
          <a:off x="176105" y="1171739"/>
          <a:ext cx="6330697" cy="4326388"/>
        </p:xfrm>
        <a:graphic>
          <a:graphicData uri="http://schemas.openxmlformats.org/drawingml/2006/table">
            <a:tbl>
              <a:tblPr/>
              <a:tblGrid>
                <a:gridCol w="663168"/>
                <a:gridCol w="1942134"/>
                <a:gridCol w="857143"/>
                <a:gridCol w="901700"/>
                <a:gridCol w="773806"/>
                <a:gridCol w="461485"/>
                <a:gridCol w="328624"/>
                <a:gridCol w="402637"/>
              </a:tblGrid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name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Coordinates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anscription factor (TF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F binding Sequence (TFBS)</a:t>
                      </a:r>
                    </a:p>
                  </a:txBody>
                  <a:tcPr marL="2728" marR="2728" marT="27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FBS Position(0-based)</a:t>
                      </a:r>
                    </a:p>
                  </a:txBody>
                  <a:tcPr marL="2728" marR="2728" marT="27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rand</a:t>
                      </a:r>
                    </a:p>
                  </a:txBody>
                  <a:tcPr marL="2728" marR="2728" marT="27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ore</a:t>
                      </a:r>
                    </a:p>
                  </a:txBody>
                  <a:tcPr marL="2728" marR="2728" marT="27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-value</a:t>
                      </a:r>
                    </a:p>
                  </a:txBody>
                  <a:tcPr marL="2728" marR="2728" marT="27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AGGGAGTCATC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E-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GCAGAGTCATA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GGGAGTCATC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7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TCTGAGACAGCA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0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2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l5 NM_013653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C_000077.6,  C57BL/6J chr11: 83530968-83530469  (-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GCAGAGTCATA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5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GTGCTGTCTCAGAGTC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1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AGTATGACTCTGCCT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GTGCTGTCTCAGAGT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4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AGTGAAGACCAATGGCT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CAGAGGACTCTGAGAC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06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TGCTGAGTCACTT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0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E-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CATGAGTCTCAA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7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5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CTGAGTCACTT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0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AGGAGTCAACT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1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6 NM_031168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C_000071.6 , C57BL/6J chr5:30012711-30013210 (+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CTTAAGTCATC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AAGTGACTCAGCACT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6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TAGCTCATTCTGCTCTG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AAGTGACTCAGCA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3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GTGCTCATGCTTCTTAG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GAGCCCACCAAGAACG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4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ATGGGACATCC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0.7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TCTCATTCAACC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5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99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AATGGGACATC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8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2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CTGTGGCAAT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.6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83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f NM_013693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C_000083.6, C57BL/6J chr17:35202446-35201947  (-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CGCTGAGGGAGCT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1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TGGCTGGCTGTGCAGA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0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AAGCTCCCTCAGCGAGG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5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TGGCTGGCTGTGCAG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TGCTGGCTGGCTGTG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7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61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TTGATGCCTGGGTGTC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78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CTGAGGCAGAC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0.89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9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CACTGAGCCTTCAG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.5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37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TGTTATTCAGG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2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8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CTGAGGCAGAC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4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.9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28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10 NM_010548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C_000067.6,  C57BL/6J chr1:131019395-131019894 (+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h1(M0049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CACAAGGCAGCCT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.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46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GCGCTTACAATGCAAA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2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3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CTGAAGGCTCAGTGGGG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6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CATTATGACCTGGGAGTG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1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5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486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CGCTTACAATGCAAA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3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8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602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8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-Maf(M00035)</a:t>
                      </a:r>
                    </a:p>
                  </a:txBody>
                  <a:tcPr marL="2728" marR="2728" marT="27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CATAATGACGTGGATAAA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7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35</a:t>
                      </a:r>
                    </a:p>
                  </a:txBody>
                  <a:tcPr marL="2728" marR="2728" marT="2728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896066" y="9469751"/>
            <a:ext cx="1169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2000" b="1" dirty="0" smtClean="0"/>
              <a:t>Table S1</a:t>
            </a:r>
            <a:endParaRPr lang="en-ZA" sz="2000" b="1" dirty="0"/>
          </a:p>
        </p:txBody>
      </p:sp>
    </p:spTree>
    <p:extLst>
      <p:ext uri="{BB962C8B-B14F-4D97-AF65-F5344CB8AC3E}">
        <p14:creationId xmlns:p14="http://schemas.microsoft.com/office/powerpoint/2010/main" val="2564461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16</TotalTime>
  <Words>349</Words>
  <Application>Microsoft Office PowerPoint</Application>
  <PresentationFormat>A4 Paper (210x297 mm)</PresentationFormat>
  <Paragraphs>33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Cape Tow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usman</dc:creator>
  <cp:lastModifiedBy>Reto Guler</cp:lastModifiedBy>
  <cp:revision>897</cp:revision>
  <cp:lastPrinted>2018-04-23T09:17:19Z</cp:lastPrinted>
  <dcterms:created xsi:type="dcterms:W3CDTF">2017-05-16T15:27:04Z</dcterms:created>
  <dcterms:modified xsi:type="dcterms:W3CDTF">2019-02-01T17:17:59Z</dcterms:modified>
</cp:coreProperties>
</file>